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67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6C64D192-33E6-CB3E-FAC9-A76D0209E744}" name="IN LEE" initials="IL" userId="FNv6GgCGt97BOSRirN17DUPPwGAzu5qmY0d7rcoe62A=" providerId="None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0B65041D-2039-483E-BA15-6439BEAF083C}" v="19" dt="2022-09-16T19:06:19.630"/>
    <p1510:client id="{1788147C-C8D6-42BD-97FB-E76778349515}" v="64" dt="2022-09-15T16:54:17.642"/>
    <p1510:client id="{3146A6AA-2177-429C-9185-3703ADB7121B}" v="114" dt="2022-09-30T18:52:02.165"/>
    <p1510:client id="{42DB5DBD-9270-44B4-A302-6C1674B09F5F}" v="4" dt="2022-09-13T19:07:26.323"/>
    <p1510:client id="{5BDFAA0B-13D0-48AD-8E1D-9EC67A1B3194}" v="8" dt="2022-09-30T18:57:18.093"/>
    <p1510:client id="{5E52C345-60C0-43B7-AA39-2F166E99BE9C}" v="2" dt="2022-09-16T22:37:26.079"/>
    <p1510:client id="{865EA627-F4F4-4171-9CD6-BF5B07BE452F}" v="4" dt="2022-09-16T18:34:29.196"/>
    <p1510:client id="{876B0E8A-30C3-4267-A84A-0A5E0829BADE}" v="8" dt="2022-09-29T02:30:43.788"/>
    <p1510:client id="{9800C2B1-23EE-42A1-8974-FC5FF225D77E}" v="3" dt="2022-09-21T16:00:32.130"/>
    <p1510:client id="{B0BB9D79-393F-4C85-B546-5604AB01667E}" v="238" dt="2022-09-13T20:07:46.837"/>
    <p1510:client id="{DCE72311-7135-4351-9D55-BF828ABE8D10}" v="293" dt="2022-09-26T18:46:00.430"/>
    <p1510:client id="{E6D6CC92-2656-4157-BC93-5CD144227428}" v="2" dt="2022-09-21T18:42:56.816"/>
    <p1510:client id="{FAF56B43-FEE7-4CA9-A1F5-13370B7503A4}" v="563" dt="2022-09-15T18:30:10.176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F5AB1C69-6EDB-4FF4-983F-18BD219EF322}" styleName="Medium Style 2 - Accent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10"/>
    <p:restoredTop sz="95833"/>
  </p:normalViewPr>
  <p:slideViewPr>
    <p:cSldViewPr snapToGrid="0" snapToObjects="1">
      <p:cViewPr varScale="1">
        <p:scale>
          <a:sx n="76" d="100"/>
          <a:sy n="76" d="100"/>
        </p:scale>
        <p:origin x="3224" y="2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8/10/relationships/authors" Target="authors.xml"/><Relationship Id="rId3" Type="http://schemas.openxmlformats.org/officeDocument/2006/relationships/presProps" Target="presProps.xml"/><Relationship Id="rId7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B20FCE-1FA8-5A41-ACF2-40CC3F04A898}" type="datetimeFigureOut">
              <a:rPr lang="en-US" smtClean="0"/>
              <a:t>3/1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892A9F-BB78-4647-B1B4-E8C2DFC240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09311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B20FCE-1FA8-5A41-ACF2-40CC3F04A898}" type="datetimeFigureOut">
              <a:rPr lang="en-US" smtClean="0"/>
              <a:t>3/1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892A9F-BB78-4647-B1B4-E8C2DFC240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58764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B20FCE-1FA8-5A41-ACF2-40CC3F04A898}" type="datetimeFigureOut">
              <a:rPr lang="en-US" smtClean="0"/>
              <a:t>3/1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892A9F-BB78-4647-B1B4-E8C2DFC240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10702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B20FCE-1FA8-5A41-ACF2-40CC3F04A898}" type="datetimeFigureOut">
              <a:rPr lang="en-US" smtClean="0"/>
              <a:t>3/1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892A9F-BB78-4647-B1B4-E8C2DFC240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18083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B20FCE-1FA8-5A41-ACF2-40CC3F04A898}" type="datetimeFigureOut">
              <a:rPr lang="en-US" smtClean="0"/>
              <a:t>3/1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892A9F-BB78-4647-B1B4-E8C2DFC240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33959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B20FCE-1FA8-5A41-ACF2-40CC3F04A898}" type="datetimeFigureOut">
              <a:rPr lang="en-US" smtClean="0"/>
              <a:t>3/17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892A9F-BB78-4647-B1B4-E8C2DFC240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99165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B20FCE-1FA8-5A41-ACF2-40CC3F04A898}" type="datetimeFigureOut">
              <a:rPr lang="en-US" smtClean="0"/>
              <a:t>3/17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892A9F-BB78-4647-B1B4-E8C2DFC240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77318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B20FCE-1FA8-5A41-ACF2-40CC3F04A898}" type="datetimeFigureOut">
              <a:rPr lang="en-US" smtClean="0"/>
              <a:t>3/17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892A9F-BB78-4647-B1B4-E8C2DFC240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53730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B20FCE-1FA8-5A41-ACF2-40CC3F04A898}" type="datetimeFigureOut">
              <a:rPr lang="en-US" smtClean="0"/>
              <a:t>3/17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892A9F-BB78-4647-B1B4-E8C2DFC240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68986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B20FCE-1FA8-5A41-ACF2-40CC3F04A898}" type="datetimeFigureOut">
              <a:rPr lang="en-US" smtClean="0"/>
              <a:t>3/17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892A9F-BB78-4647-B1B4-E8C2DFC240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05718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B20FCE-1FA8-5A41-ACF2-40CC3F04A898}" type="datetimeFigureOut">
              <a:rPr lang="en-US" smtClean="0"/>
              <a:t>3/17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892A9F-BB78-4647-B1B4-E8C2DFC240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27941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5B20FCE-1FA8-5A41-ACF2-40CC3F04A898}" type="datetimeFigureOut">
              <a:rPr lang="en-US" smtClean="0"/>
              <a:t>3/1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892A9F-BB78-4647-B1B4-E8C2DFC240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6595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E076C2B4-792D-7F40-A4A5-E4F06C6332D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37102760"/>
              </p:ext>
            </p:extLst>
          </p:nvPr>
        </p:nvGraphicFramePr>
        <p:xfrm>
          <a:off x="292589" y="431234"/>
          <a:ext cx="6050610" cy="2930802"/>
        </p:xfrm>
        <a:graphic>
          <a:graphicData uri="http://schemas.openxmlformats.org/drawingml/2006/table">
            <a:tbl>
              <a:tblPr firstRow="1" firstCol="1" bandRow="1">
                <a:tableStyleId>{F5AB1C69-6EDB-4FF4-983F-18BD219EF322}</a:tableStyleId>
              </a:tblPr>
              <a:tblGrid>
                <a:gridCol w="753900">
                  <a:extLst>
                    <a:ext uri="{9D8B030D-6E8A-4147-A177-3AD203B41FA5}">
                      <a16:colId xmlns:a16="http://schemas.microsoft.com/office/drawing/2014/main" val="3257953582"/>
                    </a:ext>
                  </a:extLst>
                </a:gridCol>
                <a:gridCol w="640653">
                  <a:extLst>
                    <a:ext uri="{9D8B030D-6E8A-4147-A177-3AD203B41FA5}">
                      <a16:colId xmlns:a16="http://schemas.microsoft.com/office/drawing/2014/main" val="3726339830"/>
                    </a:ext>
                  </a:extLst>
                </a:gridCol>
                <a:gridCol w="599884">
                  <a:extLst>
                    <a:ext uri="{9D8B030D-6E8A-4147-A177-3AD203B41FA5}">
                      <a16:colId xmlns:a16="http://schemas.microsoft.com/office/drawing/2014/main" val="2180953869"/>
                    </a:ext>
                  </a:extLst>
                </a:gridCol>
                <a:gridCol w="1729762">
                  <a:extLst>
                    <a:ext uri="{9D8B030D-6E8A-4147-A177-3AD203B41FA5}">
                      <a16:colId xmlns:a16="http://schemas.microsoft.com/office/drawing/2014/main" val="85190624"/>
                    </a:ext>
                  </a:extLst>
                </a:gridCol>
                <a:gridCol w="2326411">
                  <a:extLst>
                    <a:ext uri="{9D8B030D-6E8A-4147-A177-3AD203B41FA5}">
                      <a16:colId xmlns:a16="http://schemas.microsoft.com/office/drawing/2014/main" val="1708206401"/>
                    </a:ext>
                  </a:extLst>
                </a:gridCol>
              </a:tblGrid>
              <a:tr h="187388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Cell line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Species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Sex</a:t>
                      </a:r>
                      <a:endParaRPr lang="en-US" sz="1200" dirty="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Mutations</a:t>
                      </a:r>
                      <a:endParaRPr lang="en-US" sz="1200" dirty="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Origin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extLst>
                  <a:ext uri="{0D108BD9-81ED-4DB2-BD59-A6C34878D82A}">
                    <a16:rowId xmlns:a16="http://schemas.microsoft.com/office/drawing/2014/main" val="1878626629"/>
                  </a:ext>
                </a:extLst>
              </a:tr>
              <a:tr h="562164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U937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Human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Male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PICALM-MLLT10, TP53</a:t>
                      </a:r>
                      <a:r>
                        <a:rPr lang="en-US" sz="1200" baseline="30000" dirty="0">
                          <a:effectLst/>
                        </a:rPr>
                        <a:t>-/-</a:t>
                      </a:r>
                      <a:r>
                        <a:rPr lang="en-US" sz="1200" dirty="0">
                          <a:effectLst/>
                        </a:rPr>
                        <a:t>, PTEN</a:t>
                      </a:r>
                      <a:r>
                        <a:rPr lang="en-US" sz="1200" baseline="30000" dirty="0">
                          <a:effectLst/>
                        </a:rPr>
                        <a:t>-/-</a:t>
                      </a:r>
                      <a:r>
                        <a:rPr lang="en-US" sz="1200" dirty="0">
                          <a:effectLst/>
                        </a:rPr>
                        <a:t>, WT1</a:t>
                      </a:r>
                      <a:r>
                        <a:rPr lang="en-US" sz="1200" baseline="30000" dirty="0">
                          <a:effectLst/>
                        </a:rPr>
                        <a:t>R301_termination/+</a:t>
                      </a:r>
                      <a:endParaRPr lang="en-US" sz="1200" dirty="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Histiocytic lymphoma</a:t>
                      </a:r>
                      <a:endParaRPr lang="en-US" sz="1200" dirty="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extLst>
                  <a:ext uri="{0D108BD9-81ED-4DB2-BD59-A6C34878D82A}">
                    <a16:rowId xmlns:a16="http://schemas.microsoft.com/office/drawing/2014/main" val="1761586416"/>
                  </a:ext>
                </a:extLst>
              </a:tr>
              <a:tr h="374776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MOLM14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Human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Male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KMT2A-MLLT3, FLT3-ITD</a:t>
                      </a:r>
                      <a:endParaRPr lang="en-US" sz="1200" dirty="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Relapsed myelodysplastic syndrome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extLst>
                  <a:ext uri="{0D108BD9-81ED-4DB2-BD59-A6C34878D82A}">
                    <a16:rowId xmlns:a16="http://schemas.microsoft.com/office/drawing/2014/main" val="587034062"/>
                  </a:ext>
                </a:extLst>
              </a:tr>
              <a:tr h="374776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HL60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Human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Female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TP53</a:t>
                      </a:r>
                      <a:r>
                        <a:rPr lang="en-US" sz="1200" baseline="30000">
                          <a:effectLst/>
                        </a:rPr>
                        <a:t>-/-</a:t>
                      </a:r>
                      <a:r>
                        <a:rPr lang="en-US" sz="1200">
                          <a:effectLst/>
                        </a:rPr>
                        <a:t>, CDKN2A null, NRAS</a:t>
                      </a:r>
                      <a:r>
                        <a:rPr lang="en-US" sz="1200" baseline="30000">
                          <a:effectLst/>
                        </a:rPr>
                        <a:t>Q61L/+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Promyelocytic leukemia</a:t>
                      </a:r>
                      <a:endParaRPr lang="en-US" sz="1200" dirty="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extLst>
                  <a:ext uri="{0D108BD9-81ED-4DB2-BD59-A6C34878D82A}">
                    <a16:rowId xmlns:a16="http://schemas.microsoft.com/office/drawing/2014/main" val="2413584874"/>
                  </a:ext>
                </a:extLst>
              </a:tr>
              <a:tr h="749552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THP1</a:t>
                      </a:r>
                      <a:endParaRPr lang="en-US" sz="1200" dirty="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Human</a:t>
                      </a:r>
                      <a:endParaRPr lang="en-US" sz="1200" dirty="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Male</a:t>
                      </a:r>
                      <a:endParaRPr lang="en-US" sz="1200" dirty="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CSNK2A1-DDX39B, KMT2A-MLLT3, NRAS</a:t>
                      </a:r>
                      <a:r>
                        <a:rPr lang="en-US" sz="1200" baseline="30000" dirty="0">
                          <a:effectLst/>
                        </a:rPr>
                        <a:t>G12D/+</a:t>
                      </a:r>
                      <a:r>
                        <a:rPr lang="en-US" sz="1200" dirty="0">
                          <a:effectLst/>
                        </a:rPr>
                        <a:t>, TP53</a:t>
                      </a:r>
                      <a:r>
                        <a:rPr lang="en-US" sz="1200" baseline="30000" dirty="0">
                          <a:effectLst/>
                        </a:rPr>
                        <a:t>R174_frameshift/+</a:t>
                      </a:r>
                      <a:endParaRPr lang="en-US" sz="1200" dirty="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Monocyte</a:t>
                      </a:r>
                      <a:endParaRPr lang="en-US" sz="1200" dirty="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extLst>
                  <a:ext uri="{0D108BD9-81ED-4DB2-BD59-A6C34878D82A}">
                    <a16:rowId xmlns:a16="http://schemas.microsoft.com/office/drawing/2014/main" val="2193772324"/>
                  </a:ext>
                </a:extLst>
              </a:tr>
              <a:tr h="682146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Calibri" panose="020F0502020204030204" pitchFamily="34" charset="0"/>
                          <a:ea typeface="Malgun Gothic" panose="020B0503020000020004" pitchFamily="34" charset="-127"/>
                          <a:cs typeface="Times New Roman" panose="02020603050405020304" pitchFamily="18" charset="0"/>
                        </a:rPr>
                        <a:t>MV4;11</a:t>
                      </a: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Calibri" panose="020F0502020204030204" pitchFamily="34" charset="0"/>
                          <a:ea typeface="Malgun Gothic" panose="020B0503020000020004" pitchFamily="34" charset="-127"/>
                          <a:cs typeface="Times New Roman" panose="02020603050405020304" pitchFamily="18" charset="0"/>
                        </a:rPr>
                        <a:t>Human</a:t>
                      </a: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Calibri" panose="020F0502020204030204" pitchFamily="34" charset="0"/>
                          <a:ea typeface="Malgun Gothic" panose="020B0503020000020004" pitchFamily="34" charset="-127"/>
                          <a:cs typeface="Times New Roman" panose="02020603050405020304" pitchFamily="18" charset="0"/>
                        </a:rPr>
                        <a:t>Male</a:t>
                      </a: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effectLst/>
                        </a:rPr>
                        <a:t>FLT3-ITD, KMT2A-AFF1</a:t>
                      </a:r>
                      <a:endParaRPr lang="en-US" sz="1200" dirty="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Calibri" panose="020F0502020204030204" pitchFamily="34" charset="0"/>
                          <a:ea typeface="Malgun Gothic" panose="020B0503020000020004" pitchFamily="34" charset="-127"/>
                          <a:cs typeface="Times New Roman" panose="02020603050405020304" pitchFamily="18" charset="0"/>
                        </a:rPr>
                        <a:t>Childhood acute monoblastic leukemia</a:t>
                      </a:r>
                    </a:p>
                  </a:txBody>
                  <a:tcPr marL="68323" marR="68323" marT="0" marB="0"/>
                </a:tc>
                <a:extLst>
                  <a:ext uri="{0D108BD9-81ED-4DB2-BD59-A6C34878D82A}">
                    <a16:rowId xmlns:a16="http://schemas.microsoft.com/office/drawing/2014/main" val="4281224357"/>
                  </a:ext>
                </a:extLst>
              </a:tr>
            </a:tbl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7C08ACEF-45EA-C84E-5EB2-A62728F030DC}"/>
              </a:ext>
            </a:extLst>
          </p:cNvPr>
          <p:cNvSpPr txBox="1"/>
          <p:nvPr/>
        </p:nvSpPr>
        <p:spPr>
          <a:xfrm>
            <a:off x="190989" y="3434785"/>
            <a:ext cx="6081987" cy="307777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sz="1400" b="1" dirty="0"/>
              <a:t>Supplementary Table S1. </a:t>
            </a:r>
            <a:r>
              <a:rPr lang="en-US" sz="1400" dirty="0"/>
              <a:t>Profile of human AML cell lines used in this study.</a:t>
            </a:r>
            <a:endParaRPr lang="en-US" sz="1400" b="1" dirty="0">
              <a:ea typeface="+mn-lt"/>
              <a:cs typeface="+mn-lt"/>
            </a:endParaRPr>
          </a:p>
        </p:txBody>
      </p:sp>
    </p:spTree>
    <p:extLst>
      <p:ext uri="{BB962C8B-B14F-4D97-AF65-F5344CB8AC3E}">
        <p14:creationId xmlns:p14="http://schemas.microsoft.com/office/powerpoint/2010/main" val="16895769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409</TotalTime>
  <Words>81</Words>
  <Application>Microsoft Macintosh PowerPoint</Application>
  <PresentationFormat>A4 Paper (210x297 mm)</PresentationFormat>
  <Paragraphs>3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ee, In</dc:creator>
  <cp:lastModifiedBy>Lee, In</cp:lastModifiedBy>
  <cp:revision>287</cp:revision>
  <dcterms:created xsi:type="dcterms:W3CDTF">2022-09-08T02:26:07Z</dcterms:created>
  <dcterms:modified xsi:type="dcterms:W3CDTF">2023-03-17T14:49:23Z</dcterms:modified>
</cp:coreProperties>
</file>